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89514-3CD6-4836-93C7-885FFB80D9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C7A1E-5F1A-4F89-8D79-922F3B7A67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C881F-266B-40E4-8E06-C577F25697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91D7D-1E11-4788-8351-14B26A1403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97F38-2BFB-4443-8747-9034BD5697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8BCDF-4C21-4A2E-94AB-2E457E14BD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7D550-A3C6-4A6A-9A18-3F52E9C31D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A4B23-F4F7-4E31-8451-11DF2A271A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CAA86-E094-4BBB-9A76-82DA21E82E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3E145-3877-48FE-927D-2A82A011B0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55C33-2312-472E-A2B7-009657DA21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4D83B-2B0A-4A20-B76C-2B9B48A53B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A15C2E-8787-4D27-B729-D041AF25E958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CuadroTexto"/>
          <p:cNvSpPr/>
          <p:nvPr/>
        </p:nvSpPr>
        <p:spPr>
          <a:xfrm>
            <a:off x="71280" y="6357960"/>
            <a:ext cx="2714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4"/>
          <p:cNvGraphicFramePr/>
          <p:nvPr/>
        </p:nvGraphicFramePr>
        <p:xfrm>
          <a:off x="357120" y="216000"/>
          <a:ext cx="8501040" cy="5829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7120" y="216000"/>
                    <a:ext cx="8501040" cy="582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4"/>
          <p:cNvGraphicFramePr/>
          <p:nvPr/>
        </p:nvGraphicFramePr>
        <p:xfrm>
          <a:off x="2214720" y="-46080"/>
          <a:ext cx="6858000" cy="7021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14720" y="-46080"/>
                    <a:ext cx="6858000" cy="702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3 CuadroTexto"/>
          <p:cNvSpPr/>
          <p:nvPr/>
        </p:nvSpPr>
        <p:spPr>
          <a:xfrm>
            <a:off x="71280" y="6000840"/>
            <a:ext cx="27147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Gluco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Object 5"/>
          <p:cNvGraphicFramePr/>
          <p:nvPr/>
        </p:nvGraphicFramePr>
        <p:xfrm>
          <a:off x="2214720" y="0"/>
          <a:ext cx="6827760" cy="6986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8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14720" y="0"/>
                    <a:ext cx="6827760" cy="6986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3 CuadroTexto"/>
          <p:cNvSpPr/>
          <p:nvPr/>
        </p:nvSpPr>
        <p:spPr>
          <a:xfrm>
            <a:off x="71280" y="6000840"/>
            <a:ext cx="27147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Xylo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Object 3"/>
          <p:cNvGraphicFramePr/>
          <p:nvPr/>
        </p:nvGraphicFramePr>
        <p:xfrm>
          <a:off x="2143080" y="-17640"/>
          <a:ext cx="6864480" cy="7020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143080" y="-17640"/>
                    <a:ext cx="6864480" cy="702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3 CuadroTexto"/>
          <p:cNvSpPr/>
          <p:nvPr/>
        </p:nvSpPr>
        <p:spPr>
          <a:xfrm>
            <a:off x="71280" y="6000840"/>
            <a:ext cx="27147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Arabino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Object 3"/>
          <p:cNvGraphicFramePr/>
          <p:nvPr/>
        </p:nvGraphicFramePr>
        <p:xfrm>
          <a:off x="4214880" y="-54000"/>
          <a:ext cx="4786200" cy="7069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4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214880" y="-54000"/>
                    <a:ext cx="4786200" cy="706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" name="3 CuadroTexto"/>
          <p:cNvSpPr/>
          <p:nvPr/>
        </p:nvSpPr>
        <p:spPr>
          <a:xfrm>
            <a:off x="71280" y="6000840"/>
            <a:ext cx="27147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S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Object 4"/>
          <p:cNvGraphicFramePr/>
          <p:nvPr/>
        </p:nvGraphicFramePr>
        <p:xfrm>
          <a:off x="928800" y="0"/>
          <a:ext cx="8153280" cy="6202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7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28800" y="0"/>
                    <a:ext cx="8153280" cy="6202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8" name="3 CuadroTexto"/>
          <p:cNvSpPr/>
          <p:nvPr/>
        </p:nvSpPr>
        <p:spPr>
          <a:xfrm>
            <a:off x="71280" y="6000840"/>
            <a:ext cx="5715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2 CuadroTexto"/>
          <p:cNvSpPr/>
          <p:nvPr/>
        </p:nvSpPr>
        <p:spPr>
          <a:xfrm>
            <a:off x="71280" y="6068880"/>
            <a:ext cx="7072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7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Object 5"/>
          <p:cNvGraphicFramePr/>
          <p:nvPr/>
        </p:nvGraphicFramePr>
        <p:xfrm>
          <a:off x="484200" y="285840"/>
          <a:ext cx="7808760" cy="5357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1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84200" y="285840"/>
                    <a:ext cx="7808760" cy="5357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8T23:01:16Z</dcterms:created>
  <dc:creator>aalevar</dc:creator>
  <dc:description/>
  <dc:language>en-US</dc:language>
  <cp:lastModifiedBy>GUILLERMO GOSSET LAGARDA</cp:lastModifiedBy>
  <dcterms:modified xsi:type="dcterms:W3CDTF">2014-11-07T22:41:06Z</dcterms:modified>
  <cp:revision>12</cp:revision>
  <dc:subject/>
  <dc:title>Diapositiva 1</dc:title>
</cp:coreProperties>
</file>